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69" r:id="rId3"/>
    <p:sldId id="267" r:id="rId4"/>
    <p:sldId id="270" r:id="rId5"/>
  </p:sldIdLst>
  <p:sldSz cx="6858000" cy="9906000" type="A4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8" d="100"/>
          <a:sy n="98" d="100"/>
        </p:scale>
        <p:origin x="2658" y="-10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7135815886249713E-2"/>
          <c:y val="5.3912219305920092E-2"/>
          <c:w val="0.84222781480827769"/>
          <c:h val="0.78528142315543892"/>
        </c:manualLayout>
      </c:layout>
      <c:scatterChart>
        <c:scatterStyle val="smoothMarker"/>
        <c:varyColors val="0"/>
        <c:ser>
          <c:idx val="3"/>
          <c:order val="0"/>
          <c:tx>
            <c:strRef>
              <c:f>FP_日の出後補正!$B$69</c:f>
              <c:strCache>
                <c:ptCount val="1"/>
                <c:pt idx="0">
                  <c:v>EMF-8/26-明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accent4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FP_日の出後補正!$C$67:$Z$67</c:f>
              <c:numCache>
                <c:formatCode>h:mm</c:formatCode>
                <c:ptCount val="24"/>
                <c:pt idx="0">
                  <c:v>7.4305555555555569E-2</c:v>
                </c:pt>
                <c:pt idx="1">
                  <c:v>9.5138888888888884E-2</c:v>
                </c:pt>
                <c:pt idx="2">
                  <c:v>0.11597222222222187</c:v>
                </c:pt>
                <c:pt idx="3">
                  <c:v>0.1368055555555559</c:v>
                </c:pt>
                <c:pt idx="4">
                  <c:v>0.15763888888888888</c:v>
                </c:pt>
                <c:pt idx="5">
                  <c:v>0.17847222222222286</c:v>
                </c:pt>
                <c:pt idx="6">
                  <c:v>0.1993055555555559</c:v>
                </c:pt>
                <c:pt idx="7">
                  <c:v>0.22013888888888888</c:v>
                </c:pt>
                <c:pt idx="8">
                  <c:v>0.24097222222222286</c:v>
                </c:pt>
                <c:pt idx="9">
                  <c:v>0.2618055555555559</c:v>
                </c:pt>
                <c:pt idx="10">
                  <c:v>0.28263888888888888</c:v>
                </c:pt>
                <c:pt idx="11">
                  <c:v>0.30347222222222192</c:v>
                </c:pt>
                <c:pt idx="12">
                  <c:v>0.32430555555555585</c:v>
                </c:pt>
                <c:pt idx="13">
                  <c:v>0.34513888888888888</c:v>
                </c:pt>
                <c:pt idx="14">
                  <c:v>0.36597222222222192</c:v>
                </c:pt>
                <c:pt idx="15">
                  <c:v>0.38680555555555551</c:v>
                </c:pt>
                <c:pt idx="16">
                  <c:v>0.40763888888888888</c:v>
                </c:pt>
              </c:numCache>
            </c:numRef>
          </c:xVal>
          <c:yVal>
            <c:numRef>
              <c:f>FP_日の出後補正!$C$69:$Z$69</c:f>
              <c:numCache>
                <c:formatCode>General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5.238095238095241</c:v>
                </c:pt>
                <c:pt idx="4">
                  <c:v>83.333333333333343</c:v>
                </c:pt>
                <c:pt idx="5">
                  <c:v>95.238095238095241</c:v>
                </c:pt>
                <c:pt idx="6">
                  <c:v>97.61904761904762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EA8-457E-973D-9A911AAAC1E7}"/>
            </c:ext>
          </c:extLst>
        </c:ser>
        <c:ser>
          <c:idx val="2"/>
          <c:order val="1"/>
          <c:tx>
            <c:strRef>
              <c:f>FP_日の出後補正!$B$70</c:f>
              <c:strCache>
                <c:ptCount val="1"/>
                <c:pt idx="0">
                  <c:v>EMF-8/26-暗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FP_日の出後補正!$C$67:$Z$67</c:f>
              <c:numCache>
                <c:formatCode>h:mm</c:formatCode>
                <c:ptCount val="24"/>
                <c:pt idx="0">
                  <c:v>7.4305555555555569E-2</c:v>
                </c:pt>
                <c:pt idx="1">
                  <c:v>9.5138888888888884E-2</c:v>
                </c:pt>
                <c:pt idx="2">
                  <c:v>0.11597222222222187</c:v>
                </c:pt>
                <c:pt idx="3">
                  <c:v>0.1368055555555559</c:v>
                </c:pt>
                <c:pt idx="4">
                  <c:v>0.15763888888888888</c:v>
                </c:pt>
                <c:pt idx="5">
                  <c:v>0.17847222222222286</c:v>
                </c:pt>
                <c:pt idx="6">
                  <c:v>0.1993055555555559</c:v>
                </c:pt>
                <c:pt idx="7">
                  <c:v>0.22013888888888888</c:v>
                </c:pt>
                <c:pt idx="8">
                  <c:v>0.24097222222222286</c:v>
                </c:pt>
                <c:pt idx="9">
                  <c:v>0.2618055555555559</c:v>
                </c:pt>
                <c:pt idx="10">
                  <c:v>0.28263888888888888</c:v>
                </c:pt>
                <c:pt idx="11">
                  <c:v>0.30347222222222192</c:v>
                </c:pt>
                <c:pt idx="12">
                  <c:v>0.32430555555555585</c:v>
                </c:pt>
                <c:pt idx="13">
                  <c:v>0.34513888888888888</c:v>
                </c:pt>
                <c:pt idx="14">
                  <c:v>0.36597222222222192</c:v>
                </c:pt>
                <c:pt idx="15">
                  <c:v>0.38680555555555551</c:v>
                </c:pt>
                <c:pt idx="16">
                  <c:v>0.40763888888888888</c:v>
                </c:pt>
              </c:numCache>
            </c:numRef>
          </c:xVal>
          <c:yVal>
            <c:numRef>
              <c:f>FP_日の出後補正!$C$70:$Z$70</c:f>
              <c:numCache>
                <c:formatCode>General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9.6153846153846168</c:v>
                </c:pt>
                <c:pt idx="3">
                  <c:v>46.153846153846146</c:v>
                </c:pt>
                <c:pt idx="4">
                  <c:v>73.076923076923066</c:v>
                </c:pt>
                <c:pt idx="5">
                  <c:v>76.923076923076906</c:v>
                </c:pt>
                <c:pt idx="6">
                  <c:v>88.461538461538439</c:v>
                </c:pt>
                <c:pt idx="7">
                  <c:v>92.307692307692278</c:v>
                </c:pt>
                <c:pt idx="8">
                  <c:v>94.230769230769198</c:v>
                </c:pt>
                <c:pt idx="9">
                  <c:v>99.999999999999972</c:v>
                </c:pt>
                <c:pt idx="10">
                  <c:v>99.999999999999972</c:v>
                </c:pt>
                <c:pt idx="11">
                  <c:v>99.999999999999972</c:v>
                </c:pt>
                <c:pt idx="12">
                  <c:v>99.999999999999972</c:v>
                </c:pt>
                <c:pt idx="13">
                  <c:v>99.999999999999972</c:v>
                </c:pt>
                <c:pt idx="14">
                  <c:v>99.999999999999972</c:v>
                </c:pt>
                <c:pt idx="15">
                  <c:v>99.999999999999972</c:v>
                </c:pt>
                <c:pt idx="16">
                  <c:v>99.99999999999997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EA8-457E-973D-9A911AAAC1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81114080"/>
        <c:axId val="581109816"/>
      </c:scatterChart>
      <c:valAx>
        <c:axId val="581114080"/>
        <c:scaling>
          <c:orientation val="minMax"/>
          <c:max val="0.42170000000000002"/>
          <c:min val="0"/>
        </c:scaling>
        <c:delete val="0"/>
        <c:axPos val="b"/>
        <c:numFmt formatCode="h:mm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81109816"/>
        <c:crosses val="autoZero"/>
        <c:crossBetween val="midCat"/>
        <c:majorUnit val="4.1700000000000008E-2"/>
      </c:valAx>
      <c:valAx>
        <c:axId val="581109816"/>
        <c:scaling>
          <c:orientation val="minMax"/>
          <c:max val="108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81114080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0627760612190078"/>
          <c:y val="0.55960800701404112"/>
          <c:w val="0.38989063867016616"/>
          <c:h val="0.1490249575161628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7135815886249713E-2"/>
          <c:y val="5.3912219305920092E-2"/>
          <c:w val="0.84222781480827769"/>
          <c:h val="0.78528142315543892"/>
        </c:manualLayout>
      </c:layout>
      <c:scatterChart>
        <c:scatterStyle val="smoothMarker"/>
        <c:varyColors val="0"/>
        <c:ser>
          <c:idx val="3"/>
          <c:order val="0"/>
          <c:tx>
            <c:strRef>
              <c:f>FP_日の出後補正!$B$65</c:f>
              <c:strCache>
                <c:ptCount val="1"/>
                <c:pt idx="0">
                  <c:v>IR64-9/14-明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4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FP_日の出後補正!$C$63:$Z$63</c:f>
              <c:numCache>
                <c:formatCode>h:mm</c:formatCode>
                <c:ptCount val="24"/>
                <c:pt idx="0">
                  <c:v>6.4583333333333354E-2</c:v>
                </c:pt>
                <c:pt idx="1">
                  <c:v>8.5416666666666669E-2</c:v>
                </c:pt>
                <c:pt idx="2">
                  <c:v>0.10624999999999965</c:v>
                </c:pt>
                <c:pt idx="3">
                  <c:v>0.12708333333333369</c:v>
                </c:pt>
                <c:pt idx="4">
                  <c:v>0.14791666666666667</c:v>
                </c:pt>
                <c:pt idx="5">
                  <c:v>0.16875000000000065</c:v>
                </c:pt>
                <c:pt idx="6">
                  <c:v>0.18958333333333369</c:v>
                </c:pt>
                <c:pt idx="7">
                  <c:v>0.21041666666666667</c:v>
                </c:pt>
                <c:pt idx="8">
                  <c:v>0.23125000000000065</c:v>
                </c:pt>
                <c:pt idx="9">
                  <c:v>0.25208333333333366</c:v>
                </c:pt>
                <c:pt idx="10">
                  <c:v>0.2729166666666667</c:v>
                </c:pt>
                <c:pt idx="11">
                  <c:v>0.29374999999999973</c:v>
                </c:pt>
                <c:pt idx="12">
                  <c:v>0.31458333333333366</c:v>
                </c:pt>
                <c:pt idx="13">
                  <c:v>0.3354166666666667</c:v>
                </c:pt>
                <c:pt idx="14">
                  <c:v>0.35624999999999973</c:v>
                </c:pt>
                <c:pt idx="15">
                  <c:v>0.37708333333333333</c:v>
                </c:pt>
                <c:pt idx="16">
                  <c:v>0.3979166666666667</c:v>
                </c:pt>
              </c:numCache>
            </c:numRef>
          </c:xVal>
          <c:yVal>
            <c:numRef>
              <c:f>FP_日の出後補正!$C$65:$Z$65</c:f>
              <c:numCache>
                <c:formatCode>General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296703296703297</c:v>
                </c:pt>
                <c:pt idx="5">
                  <c:v>24.175824175824175</c:v>
                </c:pt>
                <c:pt idx="6">
                  <c:v>70.329670329670336</c:v>
                </c:pt>
                <c:pt idx="7">
                  <c:v>97.80219780219781</c:v>
                </c:pt>
                <c:pt idx="8">
                  <c:v>100.00000000000001</c:v>
                </c:pt>
                <c:pt idx="9">
                  <c:v>100.00000000000001</c:v>
                </c:pt>
                <c:pt idx="10">
                  <c:v>100.00000000000001</c:v>
                </c:pt>
                <c:pt idx="11">
                  <c:v>100.00000000000001</c:v>
                </c:pt>
                <c:pt idx="12">
                  <c:v>100.00000000000001</c:v>
                </c:pt>
                <c:pt idx="13">
                  <c:v>100.00000000000001</c:v>
                </c:pt>
                <c:pt idx="14">
                  <c:v>100.00000000000001</c:v>
                </c:pt>
                <c:pt idx="15">
                  <c:v>100.00000000000001</c:v>
                </c:pt>
                <c:pt idx="16">
                  <c:v>100.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2DD-46F0-832D-5B55A41BAFB6}"/>
            </c:ext>
          </c:extLst>
        </c:ser>
        <c:ser>
          <c:idx val="2"/>
          <c:order val="1"/>
          <c:tx>
            <c:strRef>
              <c:f>FP_日の出後補正!$B$66</c:f>
              <c:strCache>
                <c:ptCount val="1"/>
                <c:pt idx="0">
                  <c:v>IR64-9/14-暗</c:v>
                </c:pt>
              </c:strCache>
            </c:strRef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rgbClr val="7030A0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FP_日の出後補正!$C$63:$Z$63</c:f>
              <c:numCache>
                <c:formatCode>h:mm</c:formatCode>
                <c:ptCount val="24"/>
                <c:pt idx="0">
                  <c:v>6.4583333333333354E-2</c:v>
                </c:pt>
                <c:pt idx="1">
                  <c:v>8.5416666666666669E-2</c:v>
                </c:pt>
                <c:pt idx="2">
                  <c:v>0.10624999999999965</c:v>
                </c:pt>
                <c:pt idx="3">
                  <c:v>0.12708333333333369</c:v>
                </c:pt>
                <c:pt idx="4">
                  <c:v>0.14791666666666667</c:v>
                </c:pt>
                <c:pt idx="5">
                  <c:v>0.16875000000000065</c:v>
                </c:pt>
                <c:pt idx="6">
                  <c:v>0.18958333333333369</c:v>
                </c:pt>
                <c:pt idx="7">
                  <c:v>0.21041666666666667</c:v>
                </c:pt>
                <c:pt idx="8">
                  <c:v>0.23125000000000065</c:v>
                </c:pt>
                <c:pt idx="9">
                  <c:v>0.25208333333333366</c:v>
                </c:pt>
                <c:pt idx="10">
                  <c:v>0.2729166666666667</c:v>
                </c:pt>
                <c:pt idx="11">
                  <c:v>0.29374999999999973</c:v>
                </c:pt>
                <c:pt idx="12">
                  <c:v>0.31458333333333366</c:v>
                </c:pt>
                <c:pt idx="13">
                  <c:v>0.3354166666666667</c:v>
                </c:pt>
                <c:pt idx="14">
                  <c:v>0.35624999999999973</c:v>
                </c:pt>
                <c:pt idx="15">
                  <c:v>0.37708333333333333</c:v>
                </c:pt>
                <c:pt idx="16">
                  <c:v>0.3979166666666667</c:v>
                </c:pt>
              </c:numCache>
            </c:numRef>
          </c:xVal>
          <c:yVal>
            <c:numRef>
              <c:f>FP_日の出後補正!$C$66:$Z$66</c:f>
              <c:numCache>
                <c:formatCode>General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2.352941176470591</c:v>
                </c:pt>
                <c:pt idx="6">
                  <c:v>57.64705882352942</c:v>
                </c:pt>
                <c:pt idx="7">
                  <c:v>85.882352941176478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2DD-46F0-832D-5B55A41BAF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81114080"/>
        <c:axId val="581109816"/>
      </c:scatterChart>
      <c:valAx>
        <c:axId val="581114080"/>
        <c:scaling>
          <c:orientation val="minMax"/>
          <c:max val="0.42170000000000002"/>
          <c:min val="0"/>
        </c:scaling>
        <c:delete val="0"/>
        <c:axPos val="b"/>
        <c:numFmt formatCode="h:mm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81109816"/>
        <c:crosses val="autoZero"/>
        <c:crossBetween val="midCat"/>
        <c:majorUnit val="4.1700000000000008E-2"/>
      </c:valAx>
      <c:valAx>
        <c:axId val="581109816"/>
        <c:scaling>
          <c:orientation val="minMax"/>
          <c:max val="108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81114080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9232783068727376"/>
          <c:y val="0.53215061485792836"/>
          <c:w val="0.38989063867016616"/>
          <c:h val="0.153435435144348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7135815886249713E-2"/>
          <c:y val="5.3912219305920092E-2"/>
          <c:w val="0.84222781480827769"/>
          <c:h val="0.78528142315543892"/>
        </c:manualLayout>
      </c:layout>
      <c:scatterChart>
        <c:scatterStyle val="smoothMarker"/>
        <c:varyColors val="0"/>
        <c:ser>
          <c:idx val="3"/>
          <c:order val="0"/>
          <c:tx>
            <c:strRef>
              <c:f>FP_日の出後補正!$B$79</c:f>
              <c:strCache>
                <c:ptCount val="1"/>
                <c:pt idx="0">
                  <c:v>IR64-Con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accent4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FP_日の出後補正!$C$76:$Z$76</c:f>
              <c:numCache>
                <c:formatCode>h:mm</c:formatCode>
                <c:ptCount val="24"/>
                <c:pt idx="0">
                  <c:v>7.0138888888888917E-2</c:v>
                </c:pt>
                <c:pt idx="1">
                  <c:v>9.0972222222222232E-2</c:v>
                </c:pt>
                <c:pt idx="2">
                  <c:v>0.11180555555555555</c:v>
                </c:pt>
                <c:pt idx="3">
                  <c:v>0.13263888888888892</c:v>
                </c:pt>
                <c:pt idx="4">
                  <c:v>0.15347222222222223</c:v>
                </c:pt>
                <c:pt idx="5">
                  <c:v>0.17430555555555555</c:v>
                </c:pt>
                <c:pt idx="6">
                  <c:v>0.19513888888888892</c:v>
                </c:pt>
                <c:pt idx="7">
                  <c:v>0.21597222222222223</c:v>
                </c:pt>
                <c:pt idx="8">
                  <c:v>0.23680555555555555</c:v>
                </c:pt>
                <c:pt idx="9">
                  <c:v>0.25763888888888892</c:v>
                </c:pt>
                <c:pt idx="10">
                  <c:v>0.27847222222222223</c:v>
                </c:pt>
                <c:pt idx="11">
                  <c:v>0.2993055555555556</c:v>
                </c:pt>
                <c:pt idx="12">
                  <c:v>0.32013888888888886</c:v>
                </c:pt>
                <c:pt idx="13">
                  <c:v>0.34097222222222223</c:v>
                </c:pt>
                <c:pt idx="14">
                  <c:v>0.36180555555555527</c:v>
                </c:pt>
                <c:pt idx="15">
                  <c:v>0.38263888888888886</c:v>
                </c:pt>
                <c:pt idx="16">
                  <c:v>0.40347222222222223</c:v>
                </c:pt>
              </c:numCache>
            </c:numRef>
          </c:xVal>
          <c:yVal>
            <c:numRef>
              <c:f>FP_日の出後補正!$C$79:$Z$79</c:f>
              <c:numCache>
                <c:formatCode>General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81300813008130091</c:v>
                </c:pt>
                <c:pt idx="5">
                  <c:v>6.5040650406504064</c:v>
                </c:pt>
                <c:pt idx="6">
                  <c:v>41.463414634146346</c:v>
                </c:pt>
                <c:pt idx="7">
                  <c:v>72.357723577235774</c:v>
                </c:pt>
                <c:pt idx="8">
                  <c:v>89.430894308943095</c:v>
                </c:pt>
                <c:pt idx="9">
                  <c:v>98.373983739837399</c:v>
                </c:pt>
                <c:pt idx="10">
                  <c:v>99.1869918699187</c:v>
                </c:pt>
                <c:pt idx="11">
                  <c:v>99.1869918699187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3D8-4AE5-8E39-AE4604F2813A}"/>
            </c:ext>
          </c:extLst>
        </c:ser>
        <c:ser>
          <c:idx val="2"/>
          <c:order val="1"/>
          <c:tx>
            <c:strRef>
              <c:f>FP_日の出後補正!$B$78</c:f>
              <c:strCache>
                <c:ptCount val="1"/>
                <c:pt idx="0">
                  <c:v>IR64-1730H-明-明</c:v>
                </c:pt>
              </c:strCache>
            </c:strRef>
          </c:tx>
          <c:spPr>
            <a:ln w="19050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diamond"/>
            <c:size val="8"/>
            <c:spPr>
              <a:solidFill>
                <a:schemeClr val="accent3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FP_日の出後補正!$C$76:$Z$76</c:f>
              <c:numCache>
                <c:formatCode>h:mm</c:formatCode>
                <c:ptCount val="24"/>
                <c:pt idx="0">
                  <c:v>7.0138888888888917E-2</c:v>
                </c:pt>
                <c:pt idx="1">
                  <c:v>9.0972222222222232E-2</c:v>
                </c:pt>
                <c:pt idx="2">
                  <c:v>0.11180555555555555</c:v>
                </c:pt>
                <c:pt idx="3">
                  <c:v>0.13263888888888892</c:v>
                </c:pt>
                <c:pt idx="4">
                  <c:v>0.15347222222222223</c:v>
                </c:pt>
                <c:pt idx="5">
                  <c:v>0.17430555555555555</c:v>
                </c:pt>
                <c:pt idx="6">
                  <c:v>0.19513888888888892</c:v>
                </c:pt>
                <c:pt idx="7">
                  <c:v>0.21597222222222223</c:v>
                </c:pt>
                <c:pt idx="8">
                  <c:v>0.23680555555555555</c:v>
                </c:pt>
                <c:pt idx="9">
                  <c:v>0.25763888888888892</c:v>
                </c:pt>
                <c:pt idx="10">
                  <c:v>0.27847222222222223</c:v>
                </c:pt>
                <c:pt idx="11">
                  <c:v>0.2993055555555556</c:v>
                </c:pt>
                <c:pt idx="12">
                  <c:v>0.32013888888888886</c:v>
                </c:pt>
                <c:pt idx="13">
                  <c:v>0.34097222222222223</c:v>
                </c:pt>
                <c:pt idx="14">
                  <c:v>0.36180555555555527</c:v>
                </c:pt>
                <c:pt idx="15">
                  <c:v>0.38263888888888886</c:v>
                </c:pt>
                <c:pt idx="16">
                  <c:v>0.40347222222222223</c:v>
                </c:pt>
              </c:numCache>
            </c:numRef>
          </c:xVal>
          <c:yVal>
            <c:numRef>
              <c:f>FP_日の出後補正!$C$78:$Z$78</c:f>
              <c:numCache>
                <c:formatCode>General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1627906976744187</c:v>
                </c:pt>
                <c:pt idx="5">
                  <c:v>6.9767441860465116</c:v>
                </c:pt>
                <c:pt idx="6">
                  <c:v>54.651162790697676</c:v>
                </c:pt>
                <c:pt idx="7">
                  <c:v>93.023255813953483</c:v>
                </c:pt>
                <c:pt idx="8">
                  <c:v>95.348837209302317</c:v>
                </c:pt>
                <c:pt idx="9">
                  <c:v>98.837209302325576</c:v>
                </c:pt>
                <c:pt idx="10">
                  <c:v>98.837209302325576</c:v>
                </c:pt>
                <c:pt idx="11">
                  <c:v>98.837209302325576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3D8-4AE5-8E39-AE4604F281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81114080"/>
        <c:axId val="581109816"/>
      </c:scatterChart>
      <c:valAx>
        <c:axId val="581114080"/>
        <c:scaling>
          <c:orientation val="minMax"/>
          <c:max val="0.42170000000000002"/>
          <c:min val="0"/>
        </c:scaling>
        <c:delete val="0"/>
        <c:axPos val="b"/>
        <c:numFmt formatCode="h:mm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81109816"/>
        <c:crosses val="autoZero"/>
        <c:crossBetween val="midCat"/>
        <c:majorUnit val="4.1700000000000008E-2"/>
      </c:valAx>
      <c:valAx>
        <c:axId val="581109816"/>
        <c:scaling>
          <c:orientation val="minMax"/>
          <c:max val="108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81114080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0083261358806119"/>
          <c:y val="0.58422082685053411"/>
          <c:w val="0.38989063867016616"/>
          <c:h val="0.139078122908340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519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8366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958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3409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167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4736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479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2587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5130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780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2507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697C4-0EEC-4837-8969-2438E8F23E77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7DE85-3AC9-40DF-A388-64AF7D7ECA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178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6459BDD4-A1EE-41D2-852B-4584205F97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8050" y="2778033"/>
            <a:ext cx="1221899" cy="3625265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270A080-24B8-4801-9CDE-8EA64A2E0D6A}"/>
              </a:ext>
            </a:extLst>
          </p:cNvPr>
          <p:cNvSpPr txBox="1"/>
          <p:nvPr/>
        </p:nvSpPr>
        <p:spPr>
          <a:xfrm>
            <a:off x="365760" y="435429"/>
            <a:ext cx="1760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2ECFF295-5854-4C39-A206-706BE7306283}"/>
              </a:ext>
            </a:extLst>
          </p:cNvPr>
          <p:cNvSpPr/>
          <p:nvPr/>
        </p:nvSpPr>
        <p:spPr>
          <a:xfrm>
            <a:off x="1714499" y="6775627"/>
            <a:ext cx="3429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Figure S1: 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A photograph of the defoliated plants. 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5963398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F98C7E4A-96BC-4FF8-9646-57FDE00278B6}"/>
              </a:ext>
            </a:extLst>
          </p:cNvPr>
          <p:cNvSpPr/>
          <p:nvPr/>
        </p:nvSpPr>
        <p:spPr>
          <a:xfrm>
            <a:off x="2149817" y="2826237"/>
            <a:ext cx="2790091" cy="2606431"/>
          </a:xfrm>
          <a:prstGeom prst="rect">
            <a:avLst/>
          </a:prstGeom>
          <a:noFill/>
          <a:ln w="762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円弧 4">
            <a:extLst>
              <a:ext uri="{FF2B5EF4-FFF2-40B4-BE49-F238E27FC236}">
                <a16:creationId xmlns:a16="http://schemas.microsoft.com/office/drawing/2014/main" id="{AF17D257-B4DB-4BAB-9637-E410B229B039}"/>
              </a:ext>
            </a:extLst>
          </p:cNvPr>
          <p:cNvSpPr/>
          <p:nvPr/>
        </p:nvSpPr>
        <p:spPr>
          <a:xfrm>
            <a:off x="4509127" y="2826237"/>
            <a:ext cx="861562" cy="886028"/>
          </a:xfrm>
          <a:prstGeom prst="arc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円弧 5">
            <a:extLst>
              <a:ext uri="{FF2B5EF4-FFF2-40B4-BE49-F238E27FC236}">
                <a16:creationId xmlns:a16="http://schemas.microsoft.com/office/drawing/2014/main" id="{A2EA9527-5B60-4459-9C62-881AF48D4095}"/>
              </a:ext>
            </a:extLst>
          </p:cNvPr>
          <p:cNvSpPr/>
          <p:nvPr/>
        </p:nvSpPr>
        <p:spPr>
          <a:xfrm rot="5400000">
            <a:off x="4521360" y="4558873"/>
            <a:ext cx="861562" cy="886028"/>
          </a:xfrm>
          <a:prstGeom prst="arc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円弧 6">
            <a:extLst>
              <a:ext uri="{FF2B5EF4-FFF2-40B4-BE49-F238E27FC236}">
                <a16:creationId xmlns:a16="http://schemas.microsoft.com/office/drawing/2014/main" id="{04A6AA11-8ED7-4FA3-B567-05984BACF019}"/>
              </a:ext>
            </a:extLst>
          </p:cNvPr>
          <p:cNvSpPr/>
          <p:nvPr/>
        </p:nvSpPr>
        <p:spPr>
          <a:xfrm rot="16200000">
            <a:off x="2162050" y="2409471"/>
            <a:ext cx="861562" cy="886028"/>
          </a:xfrm>
          <a:prstGeom prst="arc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円弧 7">
            <a:extLst>
              <a:ext uri="{FF2B5EF4-FFF2-40B4-BE49-F238E27FC236}">
                <a16:creationId xmlns:a16="http://schemas.microsoft.com/office/drawing/2014/main" id="{9C9A6700-9698-40CF-8887-89056D760B8C}"/>
              </a:ext>
            </a:extLst>
          </p:cNvPr>
          <p:cNvSpPr/>
          <p:nvPr/>
        </p:nvSpPr>
        <p:spPr>
          <a:xfrm>
            <a:off x="4090579" y="2383223"/>
            <a:ext cx="861562" cy="886028"/>
          </a:xfrm>
          <a:prstGeom prst="arc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3215FF5-F7B6-409D-A4DD-20087CA81280}"/>
              </a:ext>
            </a:extLst>
          </p:cNvPr>
          <p:cNvSpPr txBox="1"/>
          <p:nvPr/>
        </p:nvSpPr>
        <p:spPr>
          <a:xfrm rot="5400000">
            <a:off x="5071989" y="3987797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6m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FDC765F-D771-43C6-8870-D1B534698B54}"/>
              </a:ext>
            </a:extLst>
          </p:cNvPr>
          <p:cNvSpPr txBox="1"/>
          <p:nvPr/>
        </p:nvSpPr>
        <p:spPr>
          <a:xfrm>
            <a:off x="3240046" y="2229334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6m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2E9F7B94-7EE7-4FD8-87CA-F762DF277369}"/>
              </a:ext>
            </a:extLst>
          </p:cNvPr>
          <p:cNvCxnSpPr>
            <a:stCxn id="4" idx="0"/>
            <a:endCxn id="4" idx="2"/>
          </p:cNvCxnSpPr>
          <p:nvPr/>
        </p:nvCxnSpPr>
        <p:spPr>
          <a:xfrm>
            <a:off x="3544863" y="2826237"/>
            <a:ext cx="0" cy="2606431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9F7C30A6-4F3B-4D8C-9707-064CEC2714FC}"/>
              </a:ext>
            </a:extLst>
          </p:cNvPr>
          <p:cNvCxnSpPr/>
          <p:nvPr/>
        </p:nvCxnSpPr>
        <p:spPr>
          <a:xfrm>
            <a:off x="2412227" y="5432668"/>
            <a:ext cx="92930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9A2D9451-AD90-483E-B3C0-29F8BE7C8857}"/>
              </a:ext>
            </a:extLst>
          </p:cNvPr>
          <p:cNvCxnSpPr>
            <a:cxnSpLocks/>
          </p:cNvCxnSpPr>
          <p:nvPr/>
        </p:nvCxnSpPr>
        <p:spPr>
          <a:xfrm>
            <a:off x="2412227" y="5432668"/>
            <a:ext cx="623618" cy="550689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15A0ED70-A8C6-4189-8787-8DF93B95F64C}"/>
              </a:ext>
            </a:extLst>
          </p:cNvPr>
          <p:cNvCxnSpPr>
            <a:cxnSpLocks/>
          </p:cNvCxnSpPr>
          <p:nvPr/>
        </p:nvCxnSpPr>
        <p:spPr>
          <a:xfrm>
            <a:off x="3544862" y="4803104"/>
            <a:ext cx="0" cy="476355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6B801DD9-D557-4E03-BE7B-8D5EB80FB3C6}"/>
              </a:ext>
            </a:extLst>
          </p:cNvPr>
          <p:cNvCxnSpPr>
            <a:cxnSpLocks/>
          </p:cNvCxnSpPr>
          <p:nvPr/>
        </p:nvCxnSpPr>
        <p:spPr>
          <a:xfrm>
            <a:off x="3546751" y="3045088"/>
            <a:ext cx="0" cy="476355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3E00518A-8AB8-4074-969D-4D796059B6C1}"/>
              </a:ext>
            </a:extLst>
          </p:cNvPr>
          <p:cNvCxnSpPr>
            <a:cxnSpLocks/>
          </p:cNvCxnSpPr>
          <p:nvPr/>
        </p:nvCxnSpPr>
        <p:spPr>
          <a:xfrm>
            <a:off x="3544862" y="3759049"/>
            <a:ext cx="0" cy="476355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7D93E024-9C34-42EF-B4A7-57B96CCDCCF4}"/>
              </a:ext>
            </a:extLst>
          </p:cNvPr>
          <p:cNvSpPr/>
          <p:nvPr/>
        </p:nvSpPr>
        <p:spPr>
          <a:xfrm>
            <a:off x="2173836" y="2866844"/>
            <a:ext cx="1345429" cy="181302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C3B6E202-8C00-4060-B3AB-CD64295F22E0}"/>
              </a:ext>
            </a:extLst>
          </p:cNvPr>
          <p:cNvCxnSpPr>
            <a:cxnSpLocks/>
          </p:cNvCxnSpPr>
          <p:nvPr/>
        </p:nvCxnSpPr>
        <p:spPr>
          <a:xfrm flipH="1" flipV="1">
            <a:off x="3574778" y="3283267"/>
            <a:ext cx="359272" cy="5638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D41B4CED-8573-44B2-B372-613195E6462A}"/>
              </a:ext>
            </a:extLst>
          </p:cNvPr>
          <p:cNvCxnSpPr>
            <a:cxnSpLocks/>
            <a:stCxn id="21" idx="0"/>
          </p:cNvCxnSpPr>
          <p:nvPr/>
        </p:nvCxnSpPr>
        <p:spPr>
          <a:xfrm flipH="1">
            <a:off x="3565300" y="3443793"/>
            <a:ext cx="361460" cy="54923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BB3D67D-09C5-4E2D-A440-62FD0AAB62D1}"/>
              </a:ext>
            </a:extLst>
          </p:cNvPr>
          <p:cNvSpPr txBox="1"/>
          <p:nvPr/>
        </p:nvSpPr>
        <p:spPr>
          <a:xfrm rot="16200000">
            <a:off x="3853182" y="3316835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its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D5500FA8-9D6F-4A2C-99CA-300A9621C2FA}"/>
              </a:ext>
            </a:extLst>
          </p:cNvPr>
          <p:cNvCxnSpPr>
            <a:cxnSpLocks/>
          </p:cNvCxnSpPr>
          <p:nvPr/>
        </p:nvCxnSpPr>
        <p:spPr>
          <a:xfrm flipV="1">
            <a:off x="2267789" y="5721279"/>
            <a:ext cx="426128" cy="30880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B13F181-5AC1-4263-94B7-CA4F38CF76C8}"/>
              </a:ext>
            </a:extLst>
          </p:cNvPr>
          <p:cNvSpPr txBox="1"/>
          <p:nvPr/>
        </p:nvSpPr>
        <p:spPr>
          <a:xfrm>
            <a:off x="1095407" y="5969670"/>
            <a:ext cx="194957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or with blackout seal</a:t>
            </a:r>
          </a:p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quipped with growth chamber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819403C-D7D5-409C-B614-4DE08A09FE77}"/>
              </a:ext>
            </a:extLst>
          </p:cNvPr>
          <p:cNvSpPr txBox="1"/>
          <p:nvPr/>
        </p:nvSpPr>
        <p:spPr>
          <a:xfrm rot="5400000">
            <a:off x="299119" y="4480766"/>
            <a:ext cx="234551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ackout curtain</a:t>
            </a:r>
          </a:p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etween dark room and pre-dark room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7624288-C444-4431-BEA9-535C25AE9B3A}"/>
              </a:ext>
            </a:extLst>
          </p:cNvPr>
          <p:cNvSpPr txBox="1"/>
          <p:nvPr/>
        </p:nvSpPr>
        <p:spPr>
          <a:xfrm>
            <a:off x="3250424" y="5626636"/>
            <a:ext cx="239820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or</a:t>
            </a:r>
          </a:p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quipped with wooden wall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BAB428E-7BF7-44C3-8659-CC20266B003B}"/>
              </a:ext>
            </a:extLst>
          </p:cNvPr>
          <p:cNvSpPr txBox="1"/>
          <p:nvPr/>
        </p:nvSpPr>
        <p:spPr>
          <a:xfrm>
            <a:off x="2360357" y="2924142"/>
            <a:ext cx="9669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rk room</a:t>
            </a:r>
            <a:endParaRPr kumimoji="1" lang="ja-JP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9BCE35E-C1D7-44D8-A539-583EDC534A6D}"/>
              </a:ext>
            </a:extLst>
          </p:cNvPr>
          <p:cNvSpPr txBox="1"/>
          <p:nvPr/>
        </p:nvSpPr>
        <p:spPr>
          <a:xfrm>
            <a:off x="3750954" y="2924142"/>
            <a:ext cx="9957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ght room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61CB0E57-49A4-4521-B157-0D10C48A472F}"/>
              </a:ext>
            </a:extLst>
          </p:cNvPr>
          <p:cNvSpPr/>
          <p:nvPr/>
        </p:nvSpPr>
        <p:spPr>
          <a:xfrm>
            <a:off x="2188622" y="4671540"/>
            <a:ext cx="1330643" cy="717395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0B2190B-0C17-4A38-84A6-751492F581BB}"/>
              </a:ext>
            </a:extLst>
          </p:cNvPr>
          <p:cNvSpPr txBox="1"/>
          <p:nvPr/>
        </p:nvSpPr>
        <p:spPr>
          <a:xfrm>
            <a:off x="2240009" y="4894833"/>
            <a:ext cx="1238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-dark room</a:t>
            </a:r>
            <a:endParaRPr kumimoji="1" lang="ja-JP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993A5E0D-EAD0-4829-871D-13C34CDDAA0A}"/>
              </a:ext>
            </a:extLst>
          </p:cNvPr>
          <p:cNvCxnSpPr>
            <a:cxnSpLocks/>
          </p:cNvCxnSpPr>
          <p:nvPr/>
        </p:nvCxnSpPr>
        <p:spPr>
          <a:xfrm flipH="1" flipV="1">
            <a:off x="3574778" y="4454006"/>
            <a:ext cx="311600" cy="2212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E655FF6-FB63-4CFA-A2FF-6E8792835FE1}"/>
              </a:ext>
            </a:extLst>
          </p:cNvPr>
          <p:cNvSpPr txBox="1"/>
          <p:nvPr/>
        </p:nvSpPr>
        <p:spPr>
          <a:xfrm rot="16200000">
            <a:off x="3169647" y="4333042"/>
            <a:ext cx="187102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oden panel</a:t>
            </a:r>
          </a:p>
          <a:p>
            <a:pPr algn="ctr"/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etween light and dark rooms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318EBEC-2853-4489-ACB4-CDA91CF7F02A}"/>
              </a:ext>
            </a:extLst>
          </p:cNvPr>
          <p:cNvSpPr txBox="1"/>
          <p:nvPr/>
        </p:nvSpPr>
        <p:spPr>
          <a:xfrm>
            <a:off x="365760" y="435429"/>
            <a:ext cx="1760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</a:p>
        </p:txBody>
      </p: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6D307BE3-D4B4-4AA8-A0DE-85818E144EEC}"/>
              </a:ext>
            </a:extLst>
          </p:cNvPr>
          <p:cNvCxnSpPr>
            <a:cxnSpLocks/>
          </p:cNvCxnSpPr>
          <p:nvPr/>
        </p:nvCxnSpPr>
        <p:spPr>
          <a:xfrm flipV="1">
            <a:off x="1662952" y="4671540"/>
            <a:ext cx="438918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71C4BFE3-882E-44EA-83BC-44A34C02CA58}"/>
              </a:ext>
            </a:extLst>
          </p:cNvPr>
          <p:cNvCxnSpPr>
            <a:cxnSpLocks/>
          </p:cNvCxnSpPr>
          <p:nvPr/>
        </p:nvCxnSpPr>
        <p:spPr>
          <a:xfrm flipH="1">
            <a:off x="3384274" y="4788000"/>
            <a:ext cx="154619" cy="491459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1E302586-FEF5-42CE-B7FC-898CC065B879}"/>
              </a:ext>
            </a:extLst>
          </p:cNvPr>
          <p:cNvCxnSpPr>
            <a:cxnSpLocks/>
          </p:cNvCxnSpPr>
          <p:nvPr/>
        </p:nvCxnSpPr>
        <p:spPr>
          <a:xfrm flipH="1" flipV="1">
            <a:off x="3522723" y="4941497"/>
            <a:ext cx="726123" cy="76651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ED35E52-9406-45C0-950F-4CBF682D3A12}"/>
              </a:ext>
            </a:extLst>
          </p:cNvPr>
          <p:cNvSpPr/>
          <p:nvPr/>
        </p:nvSpPr>
        <p:spPr>
          <a:xfrm>
            <a:off x="1508167" y="6783042"/>
            <a:ext cx="407716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Figure S2: Design of the light and dark rooms in a greenhouse. A view from the top. 1.75m in height.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913958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96990A26-3859-431C-8635-66DEB5EBE29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3207676"/>
              </p:ext>
            </p:extLst>
          </p:nvPr>
        </p:nvGraphicFramePr>
        <p:xfrm>
          <a:off x="1042633" y="4396700"/>
          <a:ext cx="4567601" cy="27328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BDB8EDD5-A059-440D-AA1A-3A503CF381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2834118"/>
              </p:ext>
            </p:extLst>
          </p:nvPr>
        </p:nvGraphicFramePr>
        <p:xfrm>
          <a:off x="1050246" y="1610997"/>
          <a:ext cx="4559988" cy="27235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4E2FE3B-A92E-4C40-803A-2715B620B74B}"/>
              </a:ext>
            </a:extLst>
          </p:cNvPr>
          <p:cNvSpPr txBox="1"/>
          <p:nvPr/>
        </p:nvSpPr>
        <p:spPr>
          <a:xfrm>
            <a:off x="356235" y="305897"/>
            <a:ext cx="1760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B56D159-289A-4556-84FA-E654B19E8D0F}"/>
              </a:ext>
            </a:extLst>
          </p:cNvPr>
          <p:cNvSpPr txBox="1"/>
          <p:nvPr/>
        </p:nvSpPr>
        <p:spPr>
          <a:xfrm>
            <a:off x="1578415" y="4337572"/>
            <a:ext cx="2311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64+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EMF3,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 August 2020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0612B69-853E-4486-8680-7127BB70E42A}"/>
              </a:ext>
            </a:extLst>
          </p:cNvPr>
          <p:cNvSpPr txBox="1"/>
          <p:nvPr/>
        </p:nvSpPr>
        <p:spPr>
          <a:xfrm>
            <a:off x="3889817" y="3039546"/>
            <a:ext cx="1431802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64-SLPL (Day 2)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64-SLPD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ay 2)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C8DD058-694B-4F50-9252-233549635D78}"/>
              </a:ext>
            </a:extLst>
          </p:cNvPr>
          <p:cNvSpPr txBox="1"/>
          <p:nvPr/>
        </p:nvSpPr>
        <p:spPr>
          <a:xfrm>
            <a:off x="1571786" y="1563390"/>
            <a:ext cx="1999265" cy="2788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IR64, 15 September 2019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01CEBCE-FE17-4CFE-A79E-117A2BAFA905}"/>
              </a:ext>
            </a:extLst>
          </p:cNvPr>
          <p:cNvSpPr txBox="1"/>
          <p:nvPr/>
        </p:nvSpPr>
        <p:spPr>
          <a:xfrm>
            <a:off x="3523840" y="5909550"/>
            <a:ext cx="213561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64+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EMF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LPL (Day 2)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64+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EMF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LPD (Day 2)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132866C-976E-45B0-914A-BF52599C5858}"/>
              </a:ext>
            </a:extLst>
          </p:cNvPr>
          <p:cNvSpPr txBox="1"/>
          <p:nvPr/>
        </p:nvSpPr>
        <p:spPr>
          <a:xfrm>
            <a:off x="2897638" y="7064424"/>
            <a:ext cx="1520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after sunrise (h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A5F439E-FBA5-47CB-AB7E-EED4DD9393C8}"/>
              </a:ext>
            </a:extLst>
          </p:cNvPr>
          <p:cNvSpPr txBox="1"/>
          <p:nvPr/>
        </p:nvSpPr>
        <p:spPr>
          <a:xfrm>
            <a:off x="1310640" y="6787425"/>
            <a:ext cx="430117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1.0     2.0     3.0    4.0     5.0      6.0     7.0     8.0    9.0    10.0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40A81B3-A514-44FA-AF2C-E8377F5D1E20}"/>
              </a:ext>
            </a:extLst>
          </p:cNvPr>
          <p:cNvSpPr txBox="1"/>
          <p:nvPr/>
        </p:nvSpPr>
        <p:spPr>
          <a:xfrm>
            <a:off x="1309057" y="3939714"/>
            <a:ext cx="430117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1.0     2.0     3.0    4.0     5.0      6.0     7.0     8.0    9.0    10.0</a:t>
            </a: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21F7C779-B62E-4452-9A67-CAC888EBC150}"/>
              </a:ext>
            </a:extLst>
          </p:cNvPr>
          <p:cNvCxnSpPr/>
          <p:nvPr/>
        </p:nvCxnSpPr>
        <p:spPr>
          <a:xfrm>
            <a:off x="1547066" y="2912049"/>
            <a:ext cx="3803596" cy="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3AEFE975-F176-47F3-9176-F036F3F1E7D5}"/>
              </a:ext>
            </a:extLst>
          </p:cNvPr>
          <p:cNvCxnSpPr/>
          <p:nvPr/>
        </p:nvCxnSpPr>
        <p:spPr>
          <a:xfrm>
            <a:off x="1540970" y="5710113"/>
            <a:ext cx="3803596" cy="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EAEAD3B-5121-4055-8F57-AFF5005C4889}"/>
              </a:ext>
            </a:extLst>
          </p:cNvPr>
          <p:cNvSpPr txBox="1"/>
          <p:nvPr/>
        </p:nvSpPr>
        <p:spPr>
          <a:xfrm rot="16200000">
            <a:off x="-682410" y="4034263"/>
            <a:ext cx="318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percentages of opened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kelet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302BB9AE-782C-4FC1-AB08-DC55D9FADCAB}"/>
              </a:ext>
            </a:extLst>
          </p:cNvPr>
          <p:cNvSpPr/>
          <p:nvPr/>
        </p:nvSpPr>
        <p:spPr>
          <a:xfrm>
            <a:off x="722815" y="7949856"/>
            <a:ext cx="569647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Figure S3: The representative flowering patterns of </a:t>
            </a:r>
            <a:r>
              <a:rPr lang="en-US" altLang="ja-JP" sz="1200" kern="0" dirty="0" err="1">
                <a:latin typeface="Times New Roman" panose="02020603050405020304" pitchFamily="18" charset="0"/>
                <a:ea typeface="TimesLTStd-Roman"/>
              </a:rPr>
              <a:t>spikelets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 in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SLPL and SLPD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 for </a:t>
            </a:r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IR64 (A, 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15 September 2019</a:t>
            </a:r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) and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SLPL and SLPD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 for </a:t>
            </a:r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IR64+</a:t>
            </a:r>
            <a:r>
              <a:rPr lang="en-US" altLang="ja-JP" sz="1200" i="1" dirty="0">
                <a:latin typeface="Times New Roman" panose="02020603050405020304" pitchFamily="18" charset="0"/>
                <a:ea typeface="游明朝" panose="02020400000000000000" pitchFamily="18" charset="-128"/>
              </a:rPr>
              <a:t>qEMF3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 (B, 27 August 2020) on Day 2 of Experiment 2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% in each time point are calculated as (</a:t>
            </a:r>
            <a:r>
              <a:rPr lang="en-US" altLang="ja-JP" sz="1200" dirty="0" err="1">
                <a:latin typeface="Times New Roman" panose="02020603050405020304" pitchFamily="18" charset="0"/>
                <a:ea typeface="ＭＳ ゴシック" panose="020B0609070205080204" pitchFamily="49" charset="-128"/>
              </a:rPr>
              <a:t>spikelets</a:t>
            </a:r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that opened at a time point)</a:t>
            </a:r>
            <a:r>
              <a:rPr lang="en-US" altLang="ja-JP" sz="1200" kern="0" dirty="0">
                <a:latin typeface="Times New Roman" panose="02020603050405020304" pitchFamily="18" charset="0"/>
              </a:rPr>
              <a:t> ÷ </a:t>
            </a:r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(the sum of all </a:t>
            </a:r>
            <a:r>
              <a:rPr lang="en-US" altLang="ja-JP" sz="1200" dirty="0" err="1">
                <a:latin typeface="Times New Roman" panose="02020603050405020304" pitchFamily="18" charset="0"/>
                <a:ea typeface="ＭＳ ゴシック" panose="020B0609070205080204" pitchFamily="49" charset="-128"/>
              </a:rPr>
              <a:t>spikelets</a:t>
            </a:r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that opened on that day)</a:t>
            </a:r>
            <a:r>
              <a:rPr lang="en-US" altLang="ja-JP" sz="1200" kern="0" dirty="0">
                <a:latin typeface="Times New Roman" panose="02020603050405020304" pitchFamily="18" charset="0"/>
              </a:rPr>
              <a:t> ×</a:t>
            </a:r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100.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 FOT50 of IR64 was 4.3 HAS and 4.4 HAS for SLPL and SLPD, respectively, on that date. FOT50 of IR64</a:t>
            </a:r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+</a:t>
            </a:r>
            <a:r>
              <a:rPr lang="en-US" altLang="ja-JP" sz="1200" i="1" dirty="0">
                <a:latin typeface="Times New Roman" panose="02020603050405020304" pitchFamily="18" charset="0"/>
                <a:ea typeface="游明朝" panose="02020400000000000000" pitchFamily="18" charset="-128"/>
              </a:rPr>
              <a:t>qEMF3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 was 3.3 HAS and 3.5 HAS for SLPL and SLPD, respectively, on that date.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5008426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3AF259AD-534A-4802-B1EE-C336DDB8F0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0905241"/>
              </p:ext>
            </p:extLst>
          </p:nvPr>
        </p:nvGraphicFramePr>
        <p:xfrm>
          <a:off x="955848" y="2620370"/>
          <a:ext cx="4568746" cy="2711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6F165CF-8229-4086-BAD4-2234996FD217}"/>
              </a:ext>
            </a:extLst>
          </p:cNvPr>
          <p:cNvSpPr txBox="1"/>
          <p:nvPr/>
        </p:nvSpPr>
        <p:spPr>
          <a:xfrm>
            <a:off x="365760" y="435429"/>
            <a:ext cx="1760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B7735D4-EEF5-4FBE-AC36-B5A9E7A7AD50}"/>
              </a:ext>
            </a:extLst>
          </p:cNvPr>
          <p:cNvSpPr txBox="1"/>
          <p:nvPr/>
        </p:nvSpPr>
        <p:spPr>
          <a:xfrm>
            <a:off x="3736978" y="4168164"/>
            <a:ext cx="2773550" cy="6001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64-SLPL (Day 3)</a:t>
            </a:r>
          </a:p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64-SDPD (dark until 1730H on Day 1 and </a:t>
            </a:r>
          </a:p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ght room thereafter) (Day 3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EA009F8-32F5-4E50-8813-10D033AC592D}"/>
              </a:ext>
            </a:extLst>
          </p:cNvPr>
          <p:cNvSpPr txBox="1"/>
          <p:nvPr/>
        </p:nvSpPr>
        <p:spPr>
          <a:xfrm>
            <a:off x="1503647" y="2481870"/>
            <a:ext cx="13067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September 20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77818B2-5FE7-400E-A63F-A1880F0DF446}"/>
              </a:ext>
            </a:extLst>
          </p:cNvPr>
          <p:cNvSpPr txBox="1"/>
          <p:nvPr/>
        </p:nvSpPr>
        <p:spPr>
          <a:xfrm>
            <a:off x="2810415" y="5229999"/>
            <a:ext cx="1520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after sunrise (h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43DECEF-F5EA-49AB-87C6-62E1DB3B9B97}"/>
              </a:ext>
            </a:extLst>
          </p:cNvPr>
          <p:cNvSpPr txBox="1"/>
          <p:nvPr/>
        </p:nvSpPr>
        <p:spPr>
          <a:xfrm>
            <a:off x="1223417" y="4953000"/>
            <a:ext cx="430117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1.0     2.0     3.0    4.0     5.0      6.0     7.0     8.0    9.0    10.0</a:t>
            </a: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BF47EB41-7FD4-4333-8F6E-88F1C3E787A8}"/>
              </a:ext>
            </a:extLst>
          </p:cNvPr>
          <p:cNvCxnSpPr/>
          <p:nvPr/>
        </p:nvCxnSpPr>
        <p:spPr>
          <a:xfrm>
            <a:off x="1449530" y="3911702"/>
            <a:ext cx="3803596" cy="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8F12FD4-3C9F-43E6-B68F-190A53C67B97}"/>
              </a:ext>
            </a:extLst>
          </p:cNvPr>
          <p:cNvSpPr txBox="1"/>
          <p:nvPr/>
        </p:nvSpPr>
        <p:spPr>
          <a:xfrm rot="16200000">
            <a:off x="-779322" y="3773202"/>
            <a:ext cx="3180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percentages of opened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kelet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%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FC3DF29-4C55-4FED-A645-82F738119ECB}"/>
              </a:ext>
            </a:extLst>
          </p:cNvPr>
          <p:cNvSpPr/>
          <p:nvPr/>
        </p:nvSpPr>
        <p:spPr>
          <a:xfrm>
            <a:off x="672517" y="6085295"/>
            <a:ext cx="544670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Figure S4: The representative flowering pattern of </a:t>
            </a:r>
            <a:r>
              <a:rPr lang="en-US" altLang="ja-JP" sz="1200" kern="0" dirty="0" err="1">
                <a:latin typeface="Times New Roman" panose="02020603050405020304" pitchFamily="18" charset="0"/>
                <a:ea typeface="TimesLTStd-Roman"/>
              </a:rPr>
              <a:t>spikelets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 in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IR64-SLPL and IR64-SDPD (</a:t>
            </a:r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dark until 1730H </a:t>
            </a:r>
            <a:r>
              <a:rPr lang="en-US" altLang="ja-JP" sz="1200">
                <a:latin typeface="Times New Roman" panose="02020603050405020304" pitchFamily="18" charset="0"/>
                <a:ea typeface="游明朝" panose="02020400000000000000" pitchFamily="18" charset="-128"/>
              </a:rPr>
              <a:t>on Day </a:t>
            </a:r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1 and light thereafter)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 on Day 3 of Experiment 3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% in each time point are calculated as (</a:t>
            </a:r>
            <a:r>
              <a:rPr lang="en-US" altLang="ja-JP" sz="1200" dirty="0" err="1">
                <a:latin typeface="Times New Roman" panose="02020603050405020304" pitchFamily="18" charset="0"/>
                <a:ea typeface="ＭＳ ゴシック" panose="020B0609070205080204" pitchFamily="49" charset="-128"/>
              </a:rPr>
              <a:t>spikelets</a:t>
            </a:r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that opened at a time point)</a:t>
            </a:r>
            <a:r>
              <a:rPr lang="en-US" altLang="ja-JP" sz="1200" kern="0" dirty="0">
                <a:latin typeface="Times New Roman" panose="02020603050405020304" pitchFamily="18" charset="0"/>
              </a:rPr>
              <a:t> ÷ </a:t>
            </a:r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(the sum of all </a:t>
            </a:r>
            <a:r>
              <a:rPr lang="en-US" altLang="ja-JP" sz="1200" dirty="0" err="1">
                <a:latin typeface="Times New Roman" panose="02020603050405020304" pitchFamily="18" charset="0"/>
                <a:ea typeface="ＭＳ ゴシック" panose="020B0609070205080204" pitchFamily="49" charset="-128"/>
              </a:rPr>
              <a:t>spikelets</a:t>
            </a:r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 that opened on that day)</a:t>
            </a:r>
            <a:r>
              <a:rPr lang="en-US" altLang="ja-JP" sz="1200" kern="0" dirty="0">
                <a:latin typeface="Times New Roman" panose="02020603050405020304" pitchFamily="18" charset="0"/>
              </a:rPr>
              <a:t> ×</a:t>
            </a:r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</a:rPr>
              <a:t>100.</a:t>
            </a:r>
            <a:r>
              <a:rPr lang="en-US" altLang="ja-JP" sz="1200" kern="0" dirty="0">
                <a:latin typeface="Times New Roman" panose="02020603050405020304" pitchFamily="18" charset="0"/>
                <a:ea typeface="TimesLTStd-Roman"/>
              </a:rPr>
              <a:t> FOT50 was 4.8 HAS and 4.7 HAS for IR64-SLPL and IR64-SDPD, respectively, on 2 September 2020.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113141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7</TotalTime>
  <Words>415</Words>
  <Application>Microsoft Office PowerPoint</Application>
  <PresentationFormat>A4 210 x 297 mm</PresentationFormat>
  <Paragraphs>41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丸　努</dc:creator>
  <cp:lastModifiedBy>石丸　努</cp:lastModifiedBy>
  <cp:revision>194</cp:revision>
  <cp:lastPrinted>2021-07-07T07:30:57Z</cp:lastPrinted>
  <dcterms:created xsi:type="dcterms:W3CDTF">2020-06-15T08:58:17Z</dcterms:created>
  <dcterms:modified xsi:type="dcterms:W3CDTF">2021-07-09T00:27:15Z</dcterms:modified>
</cp:coreProperties>
</file>